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-114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E59CE-1C23-4C37-BD74-5D58F76A7E34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5BAAB-B191-4B67-A8FE-95729B41A6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57564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E59CE-1C23-4C37-BD74-5D58F76A7E34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5BAAB-B191-4B67-A8FE-95729B41A6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31194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E59CE-1C23-4C37-BD74-5D58F76A7E34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5BAAB-B191-4B67-A8FE-95729B41A6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9445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E59CE-1C23-4C37-BD74-5D58F76A7E34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5BAAB-B191-4B67-A8FE-95729B41A6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60731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E59CE-1C23-4C37-BD74-5D58F76A7E34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5BAAB-B191-4B67-A8FE-95729B41A6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68097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E59CE-1C23-4C37-BD74-5D58F76A7E34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5BAAB-B191-4B67-A8FE-95729B41A6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68046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E59CE-1C23-4C37-BD74-5D58F76A7E34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5BAAB-B191-4B67-A8FE-95729B41A6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26362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E59CE-1C23-4C37-BD74-5D58F76A7E34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5BAAB-B191-4B67-A8FE-95729B41A6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9572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E59CE-1C23-4C37-BD74-5D58F76A7E34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5BAAB-B191-4B67-A8FE-95729B41A6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20625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E59CE-1C23-4C37-BD74-5D58F76A7E34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5BAAB-B191-4B67-A8FE-95729B41A6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11192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4E59CE-1C23-4C37-BD74-5D58F76A7E34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E5BAAB-B191-4B67-A8FE-95729B41A6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58987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4E59CE-1C23-4C37-BD74-5D58F76A7E34}" type="datetimeFigureOut">
              <a:rPr lang="en-US" smtClean="0"/>
              <a:t>3/14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E5BAAB-B191-4B67-A8FE-95729B41A6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402934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8200" y="305839"/>
            <a:ext cx="3291840" cy="314221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1999" y="304800"/>
            <a:ext cx="3291840" cy="311003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028" name="Picture 4"/>
          <p:cNvPicPr>
            <a:picLocks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42010" y="3505200"/>
            <a:ext cx="3291840" cy="310896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4" name="Rectangle 3"/>
          <p:cNvSpPr/>
          <p:nvPr/>
        </p:nvSpPr>
        <p:spPr>
          <a:xfrm>
            <a:off x="4571999" y="4421043"/>
            <a:ext cx="3505200" cy="12772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smtClean="0">
                <a:latin typeface="Arial" panose="020B0604020202020204" pitchFamily="34" charset="0"/>
                <a:cs typeface="Arial" panose="020B0604020202020204" pitchFamily="34" charset="0"/>
              </a:rPr>
              <a:t>SF2. </a:t>
            </a:r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Vitamin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D mediated changes in the expression of genes in the oxidative stress regulatory network in 143B human OS cells during proliferation (A), post-proliferation (B), and differentiation (C). The yellow color denotes transcription factors while the green and red color indicate vitamin D induced down and up regulated genes, respectively.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762000" y="228600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495800" y="228600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62000" y="3429000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4269128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63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Veteran Affair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rimella, Rama (KCVA)</dc:creator>
  <cp:lastModifiedBy>Garimella, Rama (KCVA)</cp:lastModifiedBy>
  <cp:revision>3</cp:revision>
  <dcterms:created xsi:type="dcterms:W3CDTF">2016-03-21T18:51:16Z</dcterms:created>
  <dcterms:modified xsi:type="dcterms:W3CDTF">2017-03-14T17:46:20Z</dcterms:modified>
</cp:coreProperties>
</file>